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8.jpeg" ContentType="image/jpeg"/>
  <Override PartName="/ppt/media/image5.wmf" ContentType="image/x-wmf"/>
  <Override PartName="/ppt/media/image7.jpeg" ContentType="image/jpeg"/>
  <Override PartName="/ppt/media/image6.wmf" ContentType="image/x-wmf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962BB47-4310-4592-A698-ADA707F6AD07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9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灯片编号占位符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6BFB794-F2A1-42A7-A1E2-896C59D47184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445AC2-D486-4F93-84F5-6E3F205B1E1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0D3479-1230-4402-8C80-891EE5423AE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CB2105-1509-41A1-A5D0-8882EF75069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867CE3-0840-4540-8D6B-B4A7816B410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BED8DD-9970-45BB-802A-3DC29FFC205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1728D0-18FD-463D-B921-795BA4C2A89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BF4992-70C9-47EF-B1D4-8BA8A3F5930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E728E0-F94E-47CA-8E81-A876A8F4683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184323-5F1D-4C43-A98C-2E0C49A65AA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DFFACA-EF06-41A7-B6FB-35FCBA9FFB8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C6E744-F42E-430D-A4F1-12B28FF86B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D718BD-5764-4739-A991-4632CA1936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5A8F0F4-89D4-49B2-A553-D55E914EE05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package" Target="../embeddings/oleObject1.xlsx"/><Relationship Id="rId6" Type="http://schemas.openxmlformats.org/officeDocument/2006/relationships/image" Target="../media/image5.wmf"/><Relationship Id="rId7" Type="http://schemas.openxmlformats.org/officeDocument/2006/relationships/package" Target="../embeddings/oleObject2.xlsx"/><Relationship Id="rId8" Type="http://schemas.openxmlformats.org/officeDocument/2006/relationships/image" Target="../media/image6.wmf"/><Relationship Id="rId9" Type="http://schemas.openxmlformats.org/officeDocument/2006/relationships/image" Target="../media/image7.jpeg"/><Relationship Id="rId10" Type="http://schemas.openxmlformats.org/officeDocument/2006/relationships/image" Target="../media/image8.jpeg"/><Relationship Id="rId11" Type="http://schemas.openxmlformats.org/officeDocument/2006/relationships/slideLayout" Target="../slideLayouts/slideLayout1.xml"/><Relationship Id="rId1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组合 40"/>
          <p:cNvGrpSpPr/>
          <p:nvPr/>
        </p:nvGrpSpPr>
        <p:grpSpPr>
          <a:xfrm>
            <a:off x="420840" y="3481560"/>
            <a:ext cx="6043320" cy="2233800"/>
            <a:chOff x="420840" y="3481560"/>
            <a:chExt cx="6043320" cy="2233800"/>
          </a:xfrm>
        </p:grpSpPr>
        <p:sp>
          <p:nvSpPr>
            <p:cNvPr id="49" name="Text Box 78"/>
            <p:cNvSpPr/>
            <p:nvPr/>
          </p:nvSpPr>
          <p:spPr>
            <a:xfrm>
              <a:off x="420840" y="3481560"/>
              <a:ext cx="345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0" name="Picture 52" descr="20"/>
            <p:cNvPicPr/>
            <p:nvPr/>
          </p:nvPicPr>
          <p:blipFill>
            <a:blip r:embed="rId1"/>
            <a:stretch/>
          </p:blipFill>
          <p:spPr>
            <a:xfrm>
              <a:off x="3594240" y="3940200"/>
              <a:ext cx="1439640" cy="1305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1" name="Picture 53" descr="50"/>
            <p:cNvPicPr/>
            <p:nvPr/>
          </p:nvPicPr>
          <p:blipFill>
            <a:blip r:embed="rId2"/>
            <a:stretch/>
          </p:blipFill>
          <p:spPr>
            <a:xfrm>
              <a:off x="4965840" y="3949560"/>
              <a:ext cx="1439640" cy="1305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2" name="Picture 54" descr="0"/>
            <p:cNvPicPr/>
            <p:nvPr/>
          </p:nvPicPr>
          <p:blipFill>
            <a:blip r:embed="rId3"/>
            <a:stretch/>
          </p:blipFill>
          <p:spPr>
            <a:xfrm>
              <a:off x="850680" y="3930840"/>
              <a:ext cx="1439640" cy="1305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3" name="Picture 55" descr="10"/>
            <p:cNvPicPr/>
            <p:nvPr/>
          </p:nvPicPr>
          <p:blipFill>
            <a:blip r:embed="rId4"/>
            <a:stretch/>
          </p:blipFill>
          <p:spPr>
            <a:xfrm>
              <a:off x="2222280" y="3938760"/>
              <a:ext cx="1439640" cy="1305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4" name="Text Box 172"/>
            <p:cNvSpPr/>
            <p:nvPr/>
          </p:nvSpPr>
          <p:spPr>
            <a:xfrm>
              <a:off x="1274040" y="4008600"/>
              <a:ext cx="4776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ontrol                             10µM                              20µM                               50µ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Line 163"/>
            <p:cNvSpPr/>
            <p:nvPr/>
          </p:nvSpPr>
          <p:spPr>
            <a:xfrm flipV="1">
              <a:off x="847440" y="4235040"/>
              <a:ext cx="2880" cy="1258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 Box 160"/>
            <p:cNvSpPr/>
            <p:nvPr/>
          </p:nvSpPr>
          <p:spPr>
            <a:xfrm rot="16200000">
              <a:off x="109800" y="4513680"/>
              <a:ext cx="1149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I Fluorescenc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 Box 161"/>
            <p:cNvSpPr/>
            <p:nvPr/>
          </p:nvSpPr>
          <p:spPr>
            <a:xfrm>
              <a:off x="791640" y="5469120"/>
              <a:ext cx="1123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Annexin V-FIT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Line 162"/>
            <p:cNvSpPr/>
            <p:nvPr/>
          </p:nvSpPr>
          <p:spPr>
            <a:xfrm>
              <a:off x="850680" y="5507280"/>
              <a:ext cx="3598920" cy="2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 Box 25"/>
            <p:cNvSpPr/>
            <p:nvPr/>
          </p:nvSpPr>
          <p:spPr>
            <a:xfrm>
              <a:off x="3051720" y="5245200"/>
              <a:ext cx="609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2.97%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 Box 26"/>
            <p:cNvSpPr/>
            <p:nvPr/>
          </p:nvSpPr>
          <p:spPr>
            <a:xfrm>
              <a:off x="4401360" y="5248440"/>
              <a:ext cx="609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3.42%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 Box 27"/>
            <p:cNvSpPr/>
            <p:nvPr/>
          </p:nvSpPr>
          <p:spPr>
            <a:xfrm>
              <a:off x="5855040" y="5251680"/>
              <a:ext cx="609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5.95%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Text Box 29"/>
            <p:cNvSpPr/>
            <p:nvPr/>
          </p:nvSpPr>
          <p:spPr>
            <a:xfrm>
              <a:off x="1648440" y="5241960"/>
              <a:ext cx="609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1.08%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Line 163"/>
            <p:cNvSpPr/>
            <p:nvPr/>
          </p:nvSpPr>
          <p:spPr>
            <a:xfrm flipV="1">
              <a:off x="6150240" y="4984920"/>
              <a:ext cx="720" cy="3240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Line 163"/>
            <p:cNvSpPr/>
            <p:nvPr/>
          </p:nvSpPr>
          <p:spPr>
            <a:xfrm flipV="1">
              <a:off x="4759560" y="4978440"/>
              <a:ext cx="720" cy="3240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Line 163"/>
            <p:cNvSpPr/>
            <p:nvPr/>
          </p:nvSpPr>
          <p:spPr>
            <a:xfrm flipV="1">
              <a:off x="3400560" y="4972320"/>
              <a:ext cx="720" cy="3240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Line 163"/>
            <p:cNvSpPr/>
            <p:nvPr/>
          </p:nvSpPr>
          <p:spPr>
            <a:xfrm flipV="1">
              <a:off x="2028600" y="4959360"/>
              <a:ext cx="720" cy="3240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7" name="组合 42"/>
          <p:cNvGrpSpPr/>
          <p:nvPr/>
        </p:nvGrpSpPr>
        <p:grpSpPr>
          <a:xfrm>
            <a:off x="411480" y="1347840"/>
            <a:ext cx="2131560" cy="2135520"/>
            <a:chOff x="411480" y="1347840"/>
            <a:chExt cx="2131560" cy="2135520"/>
          </a:xfrm>
        </p:grpSpPr>
        <p:grpSp>
          <p:nvGrpSpPr>
            <p:cNvPr id="68" name="Group 2"/>
            <p:cNvGrpSpPr/>
            <p:nvPr/>
          </p:nvGrpSpPr>
          <p:grpSpPr>
            <a:xfrm>
              <a:off x="695160" y="1423800"/>
              <a:ext cx="1847880" cy="1904400"/>
              <a:chOff x="695160" y="1423800"/>
              <a:chExt cx="1847880" cy="1904400"/>
            </a:xfrm>
          </p:grpSpPr>
          <p:sp>
            <p:nvSpPr>
              <p:cNvPr id="69" name="Text Box 6"/>
              <p:cNvSpPr/>
              <p:nvPr/>
            </p:nvSpPr>
            <p:spPr>
              <a:xfrm rot="16200000">
                <a:off x="50400" y="2126160"/>
                <a:ext cx="15202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p53/</a:t>
                </a:r>
                <a:r>
                  <a:rPr b="1" lang="el-GR" sz="900" spc="-1" strike="noStrike">
                    <a:solidFill>
                      <a:srgbClr val="000000"/>
                    </a:solidFill>
                    <a:latin typeface="Arial"/>
                  </a:rPr>
                  <a:t>β</a:t>
                </a: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-actin mRNA levels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aphicFrame>
            <p:nvGraphicFramePr>
              <p:cNvPr id="70" name="Object 47"/>
              <p:cNvGraphicFramePr/>
              <p:nvPr/>
            </p:nvGraphicFramePr>
            <p:xfrm>
              <a:off x="761760" y="1423800"/>
              <a:ext cx="1781280" cy="1904400"/>
            </p:xfrm>
            <a:graphic>
              <a:graphicData uri="http://schemas.openxmlformats.org/presentationml/2006/ole">
                <p:oleObj progId="Excel.Sheet.12" r:id="rId5" spid="">
                  <p:embed/>
                  <p:pic>
                    <p:nvPicPr>
                      <p:cNvPr id="71" name="Object 47" descr=""/>
                      <p:cNvPicPr/>
                      <p:nvPr/>
                    </p:nvPicPr>
                    <p:blipFill>
                      <a:blip r:embed="rId6"/>
                      <a:stretch/>
                    </p:blipFill>
                    <p:spPr>
                      <a:xfrm>
                        <a:off x="761760" y="1423800"/>
                        <a:ext cx="1781280" cy="190440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</p:grpSp>
        <p:sp>
          <p:nvSpPr>
            <p:cNvPr id="72" name="Text Box 73"/>
            <p:cNvSpPr/>
            <p:nvPr/>
          </p:nvSpPr>
          <p:spPr>
            <a:xfrm>
              <a:off x="411480" y="1347840"/>
              <a:ext cx="345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直接连接符 34"/>
            <p:cNvSpPr/>
            <p:nvPr/>
          </p:nvSpPr>
          <p:spPr>
            <a:xfrm>
              <a:off x="1704960" y="3252960"/>
              <a:ext cx="761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TextBox 35"/>
            <p:cNvSpPr/>
            <p:nvPr/>
          </p:nvSpPr>
          <p:spPr>
            <a:xfrm>
              <a:off x="1708920" y="3252240"/>
              <a:ext cx="759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P53 siRNA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5" name="组合 41"/>
          <p:cNvGrpSpPr/>
          <p:nvPr/>
        </p:nvGrpSpPr>
        <p:grpSpPr>
          <a:xfrm>
            <a:off x="4676760" y="1424160"/>
            <a:ext cx="1800360" cy="2057760"/>
            <a:chOff x="4676760" y="1424160"/>
            <a:chExt cx="1800360" cy="2057760"/>
          </a:xfrm>
        </p:grpSpPr>
        <p:graphicFrame>
          <p:nvGraphicFramePr>
            <p:cNvPr id="76" name="Object 3"/>
            <p:cNvGraphicFramePr/>
            <p:nvPr/>
          </p:nvGraphicFramePr>
          <p:xfrm>
            <a:off x="4676760" y="1424160"/>
            <a:ext cx="1800360" cy="2053440"/>
          </p:xfrm>
          <a:graphic>
            <a:graphicData uri="http://schemas.openxmlformats.org/presentationml/2006/ole">
              <p:oleObj progId="Excel.Sheet.12" r:id="rId7" spid="">
                <p:embed/>
                <p:pic>
                  <p:nvPicPr>
                    <p:cNvPr id="77" name="Object 3" descr=""/>
                    <p:cNvPicPr/>
                    <p:nvPr/>
                  </p:nvPicPr>
                  <p:blipFill>
                    <a:blip r:embed="rId8"/>
                    <a:stretch/>
                  </p:blipFill>
                  <p:spPr>
                    <a:xfrm>
                      <a:off x="4676760" y="1424160"/>
                      <a:ext cx="1800360" cy="20534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78" name="TextBox 36"/>
            <p:cNvSpPr/>
            <p:nvPr/>
          </p:nvSpPr>
          <p:spPr>
            <a:xfrm>
              <a:off x="5650920" y="3250800"/>
              <a:ext cx="759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P53 siRNA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直接连接符 37"/>
            <p:cNvSpPr/>
            <p:nvPr/>
          </p:nvSpPr>
          <p:spPr>
            <a:xfrm>
              <a:off x="5608800" y="3305520"/>
              <a:ext cx="7621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0" name="组合 40"/>
          <p:cNvGrpSpPr/>
          <p:nvPr/>
        </p:nvGrpSpPr>
        <p:grpSpPr>
          <a:xfrm>
            <a:off x="2687400" y="1347840"/>
            <a:ext cx="2032920" cy="1720440"/>
            <a:chOff x="2687400" y="1347840"/>
            <a:chExt cx="2032920" cy="1720440"/>
          </a:xfrm>
        </p:grpSpPr>
        <p:pic>
          <p:nvPicPr>
            <p:cNvPr id="81" name="Picture 8" descr="Analysis 副本"/>
            <p:cNvPicPr/>
            <p:nvPr/>
          </p:nvPicPr>
          <p:blipFill>
            <a:blip r:embed="rId9"/>
            <a:srcRect l="0" t="32520" r="5025" b="15854"/>
            <a:stretch/>
          </p:blipFill>
          <p:spPr>
            <a:xfrm>
              <a:off x="3233520" y="2819520"/>
              <a:ext cx="1440000" cy="24444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pic>
          <p:nvPicPr>
            <p:cNvPr id="82" name="Picture 9" descr="Analysis  副本"/>
            <p:cNvPicPr/>
            <p:nvPr/>
          </p:nvPicPr>
          <p:blipFill>
            <a:blip r:embed="rId10"/>
            <a:stretch/>
          </p:blipFill>
          <p:spPr>
            <a:xfrm>
              <a:off x="3233520" y="2399040"/>
              <a:ext cx="1440000" cy="23976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sp>
          <p:nvSpPr>
            <p:cNvPr id="83" name="Rectangle 149"/>
            <p:cNvSpPr/>
            <p:nvPr/>
          </p:nvSpPr>
          <p:spPr>
            <a:xfrm>
              <a:off x="2687400" y="2822040"/>
              <a:ext cx="624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</a:t>
              </a:r>
              <a:r>
                <a:rPr b="1" lang="el-GR" sz="1000" spc="-1" strike="noStrike">
                  <a:solidFill>
                    <a:srgbClr val="000000"/>
                  </a:solidFill>
                  <a:latin typeface="Arial"/>
                </a:rPr>
                <a:t>-actin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Text Box 11"/>
            <p:cNvSpPr/>
            <p:nvPr/>
          </p:nvSpPr>
          <p:spPr>
            <a:xfrm>
              <a:off x="2866680" y="2409840"/>
              <a:ext cx="398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5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Text Box 12"/>
            <p:cNvSpPr/>
            <p:nvPr/>
          </p:nvSpPr>
          <p:spPr>
            <a:xfrm>
              <a:off x="3324960" y="2190960"/>
              <a:ext cx="1395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NC      50nM   100n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Text Box 13"/>
            <p:cNvSpPr/>
            <p:nvPr/>
          </p:nvSpPr>
          <p:spPr>
            <a:xfrm>
              <a:off x="3337560" y="2602440"/>
              <a:ext cx="1337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          0.78      0.52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Text Box 14"/>
            <p:cNvSpPr/>
            <p:nvPr/>
          </p:nvSpPr>
          <p:spPr>
            <a:xfrm>
              <a:off x="2973240" y="1347840"/>
              <a:ext cx="345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直接连接符 38"/>
            <p:cNvSpPr/>
            <p:nvPr/>
          </p:nvSpPr>
          <p:spPr>
            <a:xfrm>
              <a:off x="3828960" y="2210040"/>
              <a:ext cx="7621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TextBox 39"/>
            <p:cNvSpPr/>
            <p:nvPr/>
          </p:nvSpPr>
          <p:spPr>
            <a:xfrm>
              <a:off x="3868200" y="1997280"/>
              <a:ext cx="686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Harmin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0" name="TextBox 44"/>
          <p:cNvSpPr/>
          <p:nvPr/>
        </p:nvSpPr>
        <p:spPr>
          <a:xfrm>
            <a:off x="463680" y="833400"/>
            <a:ext cx="1287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 S2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zhengfang</cp:lastModifiedBy>
  <dcterms:modified xsi:type="dcterms:W3CDTF">2012-11-29T08:09:07Z</dcterms:modified>
  <cp:revision>31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